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6" r:id="rId3"/>
    <p:sldId id="257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70" r:id="rId12"/>
    <p:sldId id="271" r:id="rId13"/>
    <p:sldId id="272" r:id="rId14"/>
    <p:sldId id="273" r:id="rId15"/>
    <p:sldId id="274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661585-E2D9-48A8-8EB6-694134DACEFC}" v="26" dt="2024-12-22T08:38:51.4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037" autoAdjust="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omzcycheer" userId="S::neomzcycheer_gmail.com#ext#@nilu365.onmicrosoft.com::99700280-fade-4706-b4d2-77ce0b72e893" providerId="AD" clId="Web-{1EA5DF8C-A0FA-7BB2-62A7-0393536B1DE4}"/>
    <pc:docChg chg="modSld">
      <pc:chgData name="neomzcycheer" userId="S::neomzcycheer_gmail.com#ext#@nilu365.onmicrosoft.com::99700280-fade-4706-b4d2-77ce0b72e893" providerId="AD" clId="Web-{1EA5DF8C-A0FA-7BB2-62A7-0393536B1DE4}" dt="2024-09-10T18:27:32.428" v="10" actId="1076"/>
      <pc:docMkLst>
        <pc:docMk/>
      </pc:docMkLst>
      <pc:sldChg chg="addSp delSp modSp">
        <pc:chgData name="neomzcycheer" userId="S::neomzcycheer_gmail.com#ext#@nilu365.onmicrosoft.com::99700280-fade-4706-b4d2-77ce0b72e893" providerId="AD" clId="Web-{1EA5DF8C-A0FA-7BB2-62A7-0393536B1DE4}" dt="2024-09-10T18:26:56.458" v="5" actId="14100"/>
        <pc:sldMkLst>
          <pc:docMk/>
          <pc:sldMk cId="1704879246" sldId="268"/>
        </pc:sldMkLst>
        <pc:picChg chg="add mod">
          <ac:chgData name="neomzcycheer" userId="S::neomzcycheer_gmail.com#ext#@nilu365.onmicrosoft.com::99700280-fade-4706-b4d2-77ce0b72e893" providerId="AD" clId="Web-{1EA5DF8C-A0FA-7BB2-62A7-0393536B1DE4}" dt="2024-09-10T18:26:56.458" v="5" actId="14100"/>
          <ac:picMkLst>
            <pc:docMk/>
            <pc:sldMk cId="1704879246" sldId="268"/>
            <ac:picMk id="2" creationId="{BC7EB472-93A0-E6AD-FDBA-05BD2FFE4895}"/>
          </ac:picMkLst>
        </pc:picChg>
        <pc:picChg chg="del">
          <ac:chgData name="neomzcycheer" userId="S::neomzcycheer_gmail.com#ext#@nilu365.onmicrosoft.com::99700280-fade-4706-b4d2-77ce0b72e893" providerId="AD" clId="Web-{1EA5DF8C-A0FA-7BB2-62A7-0393536B1DE4}" dt="2024-09-10T18:26:45.677" v="0"/>
          <ac:picMkLst>
            <pc:docMk/>
            <pc:sldMk cId="1704879246" sldId="268"/>
            <ac:picMk id="25" creationId="{E67C326C-A9F6-8BD1-3E68-242BA07D7DD8}"/>
          </ac:picMkLst>
        </pc:picChg>
      </pc:sldChg>
      <pc:sldChg chg="addSp delSp modSp">
        <pc:chgData name="neomzcycheer" userId="S::neomzcycheer_gmail.com#ext#@nilu365.onmicrosoft.com::99700280-fade-4706-b4d2-77ce0b72e893" providerId="AD" clId="Web-{1EA5DF8C-A0FA-7BB2-62A7-0393536B1DE4}" dt="2024-09-10T18:27:32.428" v="10" actId="1076"/>
        <pc:sldMkLst>
          <pc:docMk/>
          <pc:sldMk cId="3356265034" sldId="270"/>
        </pc:sldMkLst>
        <pc:picChg chg="del">
          <ac:chgData name="neomzcycheer" userId="S::neomzcycheer_gmail.com#ext#@nilu365.onmicrosoft.com::99700280-fade-4706-b4d2-77ce0b72e893" providerId="AD" clId="Web-{1EA5DF8C-A0FA-7BB2-62A7-0393536B1DE4}" dt="2024-09-10T18:27:06.021" v="6"/>
          <ac:picMkLst>
            <pc:docMk/>
            <pc:sldMk cId="3356265034" sldId="270"/>
            <ac:picMk id="2" creationId="{25E300C9-FD9B-C1AE-B218-FE5D30FE9995}"/>
          </ac:picMkLst>
        </pc:picChg>
        <pc:picChg chg="add mod">
          <ac:chgData name="neomzcycheer" userId="S::neomzcycheer_gmail.com#ext#@nilu365.onmicrosoft.com::99700280-fade-4706-b4d2-77ce0b72e893" providerId="AD" clId="Web-{1EA5DF8C-A0FA-7BB2-62A7-0393536B1DE4}" dt="2024-09-10T18:27:32.428" v="10" actId="1076"/>
          <ac:picMkLst>
            <pc:docMk/>
            <pc:sldMk cId="3356265034" sldId="270"/>
            <ac:picMk id="3" creationId="{21EF11A6-3A81-3CF3-26B8-1E24486C2D4F}"/>
          </ac:picMkLst>
        </pc:picChg>
      </pc:sldChg>
      <pc:sldChg chg="modSp">
        <pc:chgData name="neomzcycheer" userId="S::neomzcycheer_gmail.com#ext#@nilu365.onmicrosoft.com::99700280-fade-4706-b4d2-77ce0b72e893" providerId="AD" clId="Web-{1EA5DF8C-A0FA-7BB2-62A7-0393536B1DE4}" dt="2024-09-10T18:27:14.443" v="8" actId="1076"/>
        <pc:sldMkLst>
          <pc:docMk/>
          <pc:sldMk cId="1128141415" sldId="271"/>
        </pc:sldMkLst>
        <pc:picChg chg="mod">
          <ac:chgData name="neomzcycheer" userId="S::neomzcycheer_gmail.com#ext#@nilu365.onmicrosoft.com::99700280-fade-4706-b4d2-77ce0b72e893" providerId="AD" clId="Web-{1EA5DF8C-A0FA-7BB2-62A7-0393536B1DE4}" dt="2024-09-10T18:27:14.443" v="8" actId="1076"/>
          <ac:picMkLst>
            <pc:docMk/>
            <pc:sldMk cId="1128141415" sldId="271"/>
            <ac:picMk id="3" creationId="{A368E0E4-8F96-128E-F319-1115069B32B2}"/>
          </ac:picMkLst>
        </pc:picChg>
      </pc:sldChg>
    </pc:docChg>
  </pc:docChgLst>
  <pc:docChgLst>
    <pc:chgData name="Ann-Karin Hardie Olsen" userId="e320bee9-3c44-4263-bfad-c0288f2c0ec5" providerId="ADAL" clId="{68661585-E2D9-48A8-8EB6-694134DACEFC}"/>
    <pc:docChg chg="custSel modSld">
      <pc:chgData name="Ann-Karin Hardie Olsen" userId="e320bee9-3c44-4263-bfad-c0288f2c0ec5" providerId="ADAL" clId="{68661585-E2D9-48A8-8EB6-694134DACEFC}" dt="2024-12-22T08:41:15.510" v="270" actId="6549"/>
      <pc:docMkLst>
        <pc:docMk/>
      </pc:docMkLst>
      <pc:sldChg chg="addSp delSp modSp mod">
        <pc:chgData name="Ann-Karin Hardie Olsen" userId="e320bee9-3c44-4263-bfad-c0288f2c0ec5" providerId="ADAL" clId="{68661585-E2D9-48A8-8EB6-694134DACEFC}" dt="2024-12-22T07:52:20.002" v="99" actId="20577"/>
        <pc:sldMkLst>
          <pc:docMk/>
          <pc:sldMk cId="4225952153" sldId="256"/>
        </pc:sldMkLst>
        <pc:spChg chg="add mod">
          <ac:chgData name="Ann-Karin Hardie Olsen" userId="e320bee9-3c44-4263-bfad-c0288f2c0ec5" providerId="ADAL" clId="{68661585-E2D9-48A8-8EB6-694134DACEFC}" dt="2024-12-22T07:41:11.739" v="3"/>
          <ac:spMkLst>
            <pc:docMk/>
            <pc:sldMk cId="4225952153" sldId="256"/>
            <ac:spMk id="2" creationId="{5C8A6379-9D7F-0E71-2BC2-DF45DBF25233}"/>
          </ac:spMkLst>
        </pc:spChg>
        <pc:spChg chg="add mod">
          <ac:chgData name="Ann-Karin Hardie Olsen" userId="e320bee9-3c44-4263-bfad-c0288f2c0ec5" providerId="ADAL" clId="{68661585-E2D9-48A8-8EB6-694134DACEFC}" dt="2024-12-22T07:41:53.615" v="9" actId="6549"/>
          <ac:spMkLst>
            <pc:docMk/>
            <pc:sldMk cId="4225952153" sldId="256"/>
            <ac:spMk id="3" creationId="{2FD95B36-C7F0-0738-62DB-D2070F909049}"/>
          </ac:spMkLst>
        </pc:spChg>
        <pc:spChg chg="del">
          <ac:chgData name="Ann-Karin Hardie Olsen" userId="e320bee9-3c44-4263-bfad-c0288f2c0ec5" providerId="ADAL" clId="{68661585-E2D9-48A8-8EB6-694134DACEFC}" dt="2024-12-22T07:42:03.760" v="10" actId="478"/>
          <ac:spMkLst>
            <pc:docMk/>
            <pc:sldMk cId="4225952153" sldId="256"/>
            <ac:spMk id="5" creationId="{C6E597D9-D255-D61C-515B-2030D28926E0}"/>
          </ac:spMkLst>
        </pc:spChg>
        <pc:spChg chg="del">
          <ac:chgData name="Ann-Karin Hardie Olsen" userId="e320bee9-3c44-4263-bfad-c0288f2c0ec5" providerId="ADAL" clId="{68661585-E2D9-48A8-8EB6-694134DACEFC}" dt="2024-12-22T07:41:17.238" v="4" actId="478"/>
          <ac:spMkLst>
            <pc:docMk/>
            <pc:sldMk cId="4225952153" sldId="256"/>
            <ac:spMk id="6" creationId="{7ECC5CA3-38FE-85B3-E77A-622D5E2D2088}"/>
          </ac:spMkLst>
        </pc:spChg>
        <pc:spChg chg="add mod">
          <ac:chgData name="Ann-Karin Hardie Olsen" userId="e320bee9-3c44-4263-bfad-c0288f2c0ec5" providerId="ADAL" clId="{68661585-E2D9-48A8-8EB6-694134DACEFC}" dt="2024-12-22T07:52:20.002" v="99" actId="20577"/>
          <ac:spMkLst>
            <pc:docMk/>
            <pc:sldMk cId="4225952153" sldId="256"/>
            <ac:spMk id="7" creationId="{DCE8D09F-A6D8-570F-2FEE-BEA0E1E2217C}"/>
          </ac:spMkLst>
        </pc:spChg>
        <pc:spChg chg="add mod">
          <ac:chgData name="Ann-Karin Hardie Olsen" userId="e320bee9-3c44-4263-bfad-c0288f2c0ec5" providerId="ADAL" clId="{68661585-E2D9-48A8-8EB6-694134DACEFC}" dt="2024-12-22T07:44:01.239" v="23" actId="1035"/>
          <ac:spMkLst>
            <pc:docMk/>
            <pc:sldMk cId="4225952153" sldId="256"/>
            <ac:spMk id="9" creationId="{AD908C7F-5252-71CA-38B3-E844BDA1A9DF}"/>
          </ac:spMkLst>
        </pc:spChg>
        <pc:spChg chg="add mod">
          <ac:chgData name="Ann-Karin Hardie Olsen" userId="e320bee9-3c44-4263-bfad-c0288f2c0ec5" providerId="ADAL" clId="{68661585-E2D9-48A8-8EB6-694134DACEFC}" dt="2024-12-22T07:43:57.984" v="22" actId="1035"/>
          <ac:spMkLst>
            <pc:docMk/>
            <pc:sldMk cId="4225952153" sldId="256"/>
            <ac:spMk id="11" creationId="{140A44A4-CD15-251B-B597-90EB43AFE164}"/>
          </ac:spMkLst>
        </pc:spChg>
        <pc:spChg chg="add mod">
          <ac:chgData name="Ann-Karin Hardie Olsen" userId="e320bee9-3c44-4263-bfad-c0288f2c0ec5" providerId="ADAL" clId="{68661585-E2D9-48A8-8EB6-694134DACEFC}" dt="2024-12-22T07:43:51.957" v="20" actId="1076"/>
          <ac:spMkLst>
            <pc:docMk/>
            <pc:sldMk cId="4225952153" sldId="256"/>
            <ac:spMk id="12" creationId="{DF1E7B3A-85D2-E99F-6BF0-DD14A04D4CE4}"/>
          </ac:spMkLst>
        </pc:spChg>
        <pc:spChg chg="add mod">
          <ac:chgData name="Ann-Karin Hardie Olsen" userId="e320bee9-3c44-4263-bfad-c0288f2c0ec5" providerId="ADAL" clId="{68661585-E2D9-48A8-8EB6-694134DACEFC}" dt="2024-12-22T07:46:31.209" v="90" actId="20577"/>
          <ac:spMkLst>
            <pc:docMk/>
            <pc:sldMk cId="4225952153" sldId="256"/>
            <ac:spMk id="13" creationId="{8ADE8CE0-A8C5-0353-3B83-07DA6C16F597}"/>
          </ac:spMkLst>
        </pc:spChg>
        <pc:spChg chg="del">
          <ac:chgData name="Ann-Karin Hardie Olsen" userId="e320bee9-3c44-4263-bfad-c0288f2c0ec5" providerId="ADAL" clId="{68661585-E2D9-48A8-8EB6-694134DACEFC}" dt="2024-12-22T07:45:40.711" v="24" actId="478"/>
          <ac:spMkLst>
            <pc:docMk/>
            <pc:sldMk cId="4225952153" sldId="256"/>
            <ac:spMk id="38" creationId="{77099841-A197-450E-9468-1DB527C5D8F9}"/>
          </ac:spMkLst>
        </pc:spChg>
      </pc:sldChg>
      <pc:sldChg chg="modSp mod">
        <pc:chgData name="Ann-Karin Hardie Olsen" userId="e320bee9-3c44-4263-bfad-c0288f2c0ec5" providerId="ADAL" clId="{68661585-E2D9-48A8-8EB6-694134DACEFC}" dt="2024-12-22T08:41:15.510" v="270" actId="6549"/>
        <pc:sldMkLst>
          <pc:docMk/>
          <pc:sldMk cId="3796257797" sldId="262"/>
        </pc:sldMkLst>
        <pc:spChg chg="mod">
          <ac:chgData name="Ann-Karin Hardie Olsen" userId="e320bee9-3c44-4263-bfad-c0288f2c0ec5" providerId="ADAL" clId="{68661585-E2D9-48A8-8EB6-694134DACEFC}" dt="2024-12-22T07:39:55.882" v="2" actId="6549"/>
          <ac:spMkLst>
            <pc:docMk/>
            <pc:sldMk cId="3796257797" sldId="262"/>
            <ac:spMk id="2" creationId="{E1C6E756-B19F-40C5-2E2C-15C32AF2D2AF}"/>
          </ac:spMkLst>
        </pc:spChg>
        <pc:spChg chg="mod">
          <ac:chgData name="Ann-Karin Hardie Olsen" userId="e320bee9-3c44-4263-bfad-c0288f2c0ec5" providerId="ADAL" clId="{68661585-E2D9-48A8-8EB6-694134DACEFC}" dt="2024-12-22T08:41:15.510" v="270" actId="6549"/>
          <ac:spMkLst>
            <pc:docMk/>
            <pc:sldMk cId="3796257797" sldId="262"/>
            <ac:spMk id="5" creationId="{1F7B9093-B544-8B38-D5E5-677EFF47460B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7:49:24.240" v="93"/>
        <pc:sldMkLst>
          <pc:docMk/>
          <pc:sldMk cId="2962040409" sldId="264"/>
        </pc:sldMkLst>
        <pc:spChg chg="add mod">
          <ac:chgData name="Ann-Karin Hardie Olsen" userId="e320bee9-3c44-4263-bfad-c0288f2c0ec5" providerId="ADAL" clId="{68661585-E2D9-48A8-8EB6-694134DACEFC}" dt="2024-12-22T07:49:24.240" v="93"/>
          <ac:spMkLst>
            <pc:docMk/>
            <pc:sldMk cId="2962040409" sldId="264"/>
            <ac:spMk id="3" creationId="{64F3FD4B-F5A0-25D1-299F-A5E33BA882F1}"/>
          </ac:spMkLst>
        </pc:spChg>
        <pc:spChg chg="del">
          <ac:chgData name="Ann-Karin Hardie Olsen" userId="e320bee9-3c44-4263-bfad-c0288f2c0ec5" providerId="ADAL" clId="{68661585-E2D9-48A8-8EB6-694134DACEFC}" dt="2024-12-22T07:49:23.751" v="92" actId="478"/>
          <ac:spMkLst>
            <pc:docMk/>
            <pc:sldMk cId="2962040409" sldId="264"/>
            <ac:spMk id="5" creationId="{2C84C151-CBD3-5CF4-021B-B2C0E7F40DAA}"/>
          </ac:spMkLst>
        </pc:spChg>
        <pc:picChg chg="mod">
          <ac:chgData name="Ann-Karin Hardie Olsen" userId="e320bee9-3c44-4263-bfad-c0288f2c0ec5" providerId="ADAL" clId="{68661585-E2D9-48A8-8EB6-694134DACEFC}" dt="2024-12-22T07:48:22.439" v="91" actId="1076"/>
          <ac:picMkLst>
            <pc:docMk/>
            <pc:sldMk cId="2962040409" sldId="264"/>
            <ac:picMk id="2" creationId="{4B6AEE55-85B2-9BE1-2B17-E6A430E6E99A}"/>
          </ac:picMkLst>
        </pc:picChg>
      </pc:sldChg>
      <pc:sldChg chg="addSp delSp modSp mod">
        <pc:chgData name="Ann-Karin Hardie Olsen" userId="e320bee9-3c44-4263-bfad-c0288f2c0ec5" providerId="ADAL" clId="{68661585-E2D9-48A8-8EB6-694134DACEFC}" dt="2024-12-22T07:51:00.473" v="95"/>
        <pc:sldMkLst>
          <pc:docMk/>
          <pc:sldMk cId="1186788983" sldId="265"/>
        </pc:sldMkLst>
        <pc:spChg chg="add mod">
          <ac:chgData name="Ann-Karin Hardie Olsen" userId="e320bee9-3c44-4263-bfad-c0288f2c0ec5" providerId="ADAL" clId="{68661585-E2D9-48A8-8EB6-694134DACEFC}" dt="2024-12-22T07:51:00.473" v="95"/>
          <ac:spMkLst>
            <pc:docMk/>
            <pc:sldMk cId="1186788983" sldId="265"/>
            <ac:spMk id="2" creationId="{A8A0D459-DB67-2519-DF44-AA906A7A07F7}"/>
          </ac:spMkLst>
        </pc:spChg>
        <pc:spChg chg="del">
          <ac:chgData name="Ann-Karin Hardie Olsen" userId="e320bee9-3c44-4263-bfad-c0288f2c0ec5" providerId="ADAL" clId="{68661585-E2D9-48A8-8EB6-694134DACEFC}" dt="2024-12-22T07:50:59.742" v="94" actId="478"/>
          <ac:spMkLst>
            <pc:docMk/>
            <pc:sldMk cId="1186788983" sldId="265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7:53:19.578" v="102"/>
        <pc:sldMkLst>
          <pc:docMk/>
          <pc:sldMk cId="1941740904" sldId="266"/>
        </pc:sldMkLst>
        <pc:spChg chg="add mod">
          <ac:chgData name="Ann-Karin Hardie Olsen" userId="e320bee9-3c44-4263-bfad-c0288f2c0ec5" providerId="ADAL" clId="{68661585-E2D9-48A8-8EB6-694134DACEFC}" dt="2024-12-22T07:53:13.209" v="100"/>
          <ac:spMkLst>
            <pc:docMk/>
            <pc:sldMk cId="1941740904" sldId="266"/>
            <ac:spMk id="3" creationId="{DE32CEB2-5E65-8A12-C7AC-D84800CC4019}"/>
          </ac:spMkLst>
        </pc:spChg>
        <pc:spChg chg="add mod">
          <ac:chgData name="Ann-Karin Hardie Olsen" userId="e320bee9-3c44-4263-bfad-c0288f2c0ec5" providerId="ADAL" clId="{68661585-E2D9-48A8-8EB6-694134DACEFC}" dt="2024-12-22T07:53:19.578" v="102"/>
          <ac:spMkLst>
            <pc:docMk/>
            <pc:sldMk cId="1941740904" sldId="266"/>
            <ac:spMk id="4" creationId="{89F865EF-E7F0-D126-9E97-27D2B08CD23F}"/>
          </ac:spMkLst>
        </pc:spChg>
        <pc:spChg chg="del">
          <ac:chgData name="Ann-Karin Hardie Olsen" userId="e320bee9-3c44-4263-bfad-c0288f2c0ec5" providerId="ADAL" clId="{68661585-E2D9-48A8-8EB6-694134DACEFC}" dt="2024-12-22T07:53:18.135" v="101" actId="478"/>
          <ac:spMkLst>
            <pc:docMk/>
            <pc:sldMk cId="1941740904" sldId="266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7:53:29.362" v="105"/>
        <pc:sldMkLst>
          <pc:docMk/>
          <pc:sldMk cId="2735378109" sldId="267"/>
        </pc:sldMkLst>
        <pc:spChg chg="add mod">
          <ac:chgData name="Ann-Karin Hardie Olsen" userId="e320bee9-3c44-4263-bfad-c0288f2c0ec5" providerId="ADAL" clId="{68661585-E2D9-48A8-8EB6-694134DACEFC}" dt="2024-12-22T07:53:24.121" v="103"/>
          <ac:spMkLst>
            <pc:docMk/>
            <pc:sldMk cId="2735378109" sldId="267"/>
            <ac:spMk id="3" creationId="{DA1F27C9-7957-02B2-D128-8233AC5F006F}"/>
          </ac:spMkLst>
        </pc:spChg>
        <pc:spChg chg="add mod">
          <ac:chgData name="Ann-Karin Hardie Olsen" userId="e320bee9-3c44-4263-bfad-c0288f2c0ec5" providerId="ADAL" clId="{68661585-E2D9-48A8-8EB6-694134DACEFC}" dt="2024-12-22T07:53:29.362" v="105"/>
          <ac:spMkLst>
            <pc:docMk/>
            <pc:sldMk cId="2735378109" sldId="267"/>
            <ac:spMk id="4" creationId="{F8EA0D04-579E-0BCF-7329-5F5BBAF24149}"/>
          </ac:spMkLst>
        </pc:spChg>
        <pc:spChg chg="del">
          <ac:chgData name="Ann-Karin Hardie Olsen" userId="e320bee9-3c44-4263-bfad-c0288f2c0ec5" providerId="ADAL" clId="{68661585-E2D9-48A8-8EB6-694134DACEFC}" dt="2024-12-22T07:53:28.016" v="104" actId="478"/>
          <ac:spMkLst>
            <pc:docMk/>
            <pc:sldMk cId="2735378109" sldId="267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8:32:00.217" v="112" actId="14100"/>
        <pc:sldMkLst>
          <pc:docMk/>
          <pc:sldMk cId="1704879246" sldId="268"/>
        </pc:sldMkLst>
        <pc:spChg chg="add mod">
          <ac:chgData name="Ann-Karin Hardie Olsen" userId="e320bee9-3c44-4263-bfad-c0288f2c0ec5" providerId="ADAL" clId="{68661585-E2D9-48A8-8EB6-694134DACEFC}" dt="2024-12-22T08:30:54.134" v="107"/>
          <ac:spMkLst>
            <pc:docMk/>
            <pc:sldMk cId="1704879246" sldId="268"/>
            <ac:spMk id="3" creationId="{BD82E16F-2124-5C38-338A-1B2F9387DFFD}"/>
          </ac:spMkLst>
        </pc:spChg>
        <pc:spChg chg="del">
          <ac:chgData name="Ann-Karin Hardie Olsen" userId="e320bee9-3c44-4263-bfad-c0288f2c0ec5" providerId="ADAL" clId="{68661585-E2D9-48A8-8EB6-694134DACEFC}" dt="2024-12-22T08:31:21.792" v="108" actId="478"/>
          <ac:spMkLst>
            <pc:docMk/>
            <pc:sldMk cId="1704879246" sldId="268"/>
            <ac:spMk id="4" creationId="{1E473976-37DD-73A6-C305-A08443EFA22A}"/>
          </ac:spMkLst>
        </pc:spChg>
        <pc:spChg chg="del">
          <ac:chgData name="Ann-Karin Hardie Olsen" userId="e320bee9-3c44-4263-bfad-c0288f2c0ec5" providerId="ADAL" clId="{68661585-E2D9-48A8-8EB6-694134DACEFC}" dt="2024-12-22T08:31:26.969" v="110" actId="478"/>
          <ac:spMkLst>
            <pc:docMk/>
            <pc:sldMk cId="1704879246" sldId="268"/>
            <ac:spMk id="5" creationId="{C6E597D9-D255-D61C-515B-2030D28926E0}"/>
          </ac:spMkLst>
        </pc:spChg>
        <pc:spChg chg="del">
          <ac:chgData name="Ann-Karin Hardie Olsen" userId="e320bee9-3c44-4263-bfad-c0288f2c0ec5" providerId="ADAL" clId="{68661585-E2D9-48A8-8EB6-694134DACEFC}" dt="2024-12-22T08:31:25.264" v="109" actId="478"/>
          <ac:spMkLst>
            <pc:docMk/>
            <pc:sldMk cId="1704879246" sldId="268"/>
            <ac:spMk id="6" creationId="{7ECC5CA3-38FE-85B3-E77A-622D5E2D2088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7" creationId="{6FAC50CF-6B16-E4F0-29BE-67EFB0AE766A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8" creationId="{A9E0B875-8326-1E63-473F-2F0B22F32B84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9" creationId="{7F35C565-BAD5-A6EA-452A-A030D1060479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10" creationId="{DB9A0512-1743-CA52-7219-7E11A13B0D01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11" creationId="{2DF859A3-9054-0FE4-6306-D0AADC77F03A}"/>
          </ac:spMkLst>
        </pc:spChg>
        <pc:spChg chg="add mod">
          <ac:chgData name="Ann-Karin Hardie Olsen" userId="e320bee9-3c44-4263-bfad-c0288f2c0ec5" providerId="ADAL" clId="{68661585-E2D9-48A8-8EB6-694134DACEFC}" dt="2024-12-22T08:31:40.152" v="111"/>
          <ac:spMkLst>
            <pc:docMk/>
            <pc:sldMk cId="1704879246" sldId="268"/>
            <ac:spMk id="12" creationId="{47B6743C-A4D4-1FED-6974-AF6E0D6CE350}"/>
          </ac:spMkLst>
        </pc:spChg>
        <pc:spChg chg="del">
          <ac:chgData name="Ann-Karin Hardie Olsen" userId="e320bee9-3c44-4263-bfad-c0288f2c0ec5" providerId="ADAL" clId="{68661585-E2D9-48A8-8EB6-694134DACEFC}" dt="2024-12-22T08:30:53.485" v="106" actId="478"/>
          <ac:spMkLst>
            <pc:docMk/>
            <pc:sldMk cId="1704879246" sldId="268"/>
            <ac:spMk id="38" creationId="{77099841-A197-450E-9468-1DB527C5D8F9}"/>
          </ac:spMkLst>
        </pc:spChg>
        <pc:picChg chg="mod">
          <ac:chgData name="Ann-Karin Hardie Olsen" userId="e320bee9-3c44-4263-bfad-c0288f2c0ec5" providerId="ADAL" clId="{68661585-E2D9-48A8-8EB6-694134DACEFC}" dt="2024-12-22T08:32:00.217" v="112" actId="14100"/>
          <ac:picMkLst>
            <pc:docMk/>
            <pc:sldMk cId="1704879246" sldId="268"/>
            <ac:picMk id="2" creationId="{BC7EB472-93A0-E6AD-FDBA-05BD2FFE4895}"/>
          </ac:picMkLst>
        </pc:picChg>
      </pc:sldChg>
      <pc:sldChg chg="addSp delSp modSp mod">
        <pc:chgData name="Ann-Karin Hardie Olsen" userId="e320bee9-3c44-4263-bfad-c0288f2c0ec5" providerId="ADAL" clId="{68661585-E2D9-48A8-8EB6-694134DACEFC}" dt="2024-12-22T08:37:49.896" v="114"/>
        <pc:sldMkLst>
          <pc:docMk/>
          <pc:sldMk cId="1128141415" sldId="271"/>
        </pc:sldMkLst>
        <pc:spChg chg="add mod">
          <ac:chgData name="Ann-Karin Hardie Olsen" userId="e320bee9-3c44-4263-bfad-c0288f2c0ec5" providerId="ADAL" clId="{68661585-E2D9-48A8-8EB6-694134DACEFC}" dt="2024-12-22T08:37:49.896" v="114"/>
          <ac:spMkLst>
            <pc:docMk/>
            <pc:sldMk cId="1128141415" sldId="271"/>
            <ac:spMk id="2" creationId="{BBFB433D-1440-CBA7-057B-F181314747F8}"/>
          </ac:spMkLst>
        </pc:spChg>
        <pc:spChg chg="del">
          <ac:chgData name="Ann-Karin Hardie Olsen" userId="e320bee9-3c44-4263-bfad-c0288f2c0ec5" providerId="ADAL" clId="{68661585-E2D9-48A8-8EB6-694134DACEFC}" dt="2024-12-22T08:37:49.115" v="113" actId="478"/>
          <ac:spMkLst>
            <pc:docMk/>
            <pc:sldMk cId="1128141415" sldId="271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8:38:13.426" v="117"/>
        <pc:sldMkLst>
          <pc:docMk/>
          <pc:sldMk cId="852268081" sldId="272"/>
        </pc:sldMkLst>
        <pc:spChg chg="add mod">
          <ac:chgData name="Ann-Karin Hardie Olsen" userId="e320bee9-3c44-4263-bfad-c0288f2c0ec5" providerId="ADAL" clId="{68661585-E2D9-48A8-8EB6-694134DACEFC}" dt="2024-12-22T08:38:09.316" v="115"/>
          <ac:spMkLst>
            <pc:docMk/>
            <pc:sldMk cId="852268081" sldId="272"/>
            <ac:spMk id="3" creationId="{76567FDB-CA6E-9B73-7503-3A023F4501DF}"/>
          </ac:spMkLst>
        </pc:spChg>
        <pc:spChg chg="add mod">
          <ac:chgData name="Ann-Karin Hardie Olsen" userId="e320bee9-3c44-4263-bfad-c0288f2c0ec5" providerId="ADAL" clId="{68661585-E2D9-48A8-8EB6-694134DACEFC}" dt="2024-12-22T08:38:13.426" v="117"/>
          <ac:spMkLst>
            <pc:docMk/>
            <pc:sldMk cId="852268081" sldId="272"/>
            <ac:spMk id="4" creationId="{36B104F8-2D7A-E331-814D-63F2429F34CC}"/>
          </ac:spMkLst>
        </pc:spChg>
        <pc:spChg chg="del">
          <ac:chgData name="Ann-Karin Hardie Olsen" userId="e320bee9-3c44-4263-bfad-c0288f2c0ec5" providerId="ADAL" clId="{68661585-E2D9-48A8-8EB6-694134DACEFC}" dt="2024-12-22T08:38:12.742" v="116" actId="478"/>
          <ac:spMkLst>
            <pc:docMk/>
            <pc:sldMk cId="852268081" sldId="272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8:39:02.303" v="130" actId="20577"/>
        <pc:sldMkLst>
          <pc:docMk/>
          <pc:sldMk cId="3766932299" sldId="273"/>
        </pc:sldMkLst>
        <pc:spChg chg="add mod">
          <ac:chgData name="Ann-Karin Hardie Olsen" userId="e320bee9-3c44-4263-bfad-c0288f2c0ec5" providerId="ADAL" clId="{68661585-E2D9-48A8-8EB6-694134DACEFC}" dt="2024-12-22T08:39:02.303" v="130" actId="20577"/>
          <ac:spMkLst>
            <pc:docMk/>
            <pc:sldMk cId="3766932299" sldId="273"/>
            <ac:spMk id="2" creationId="{48913E0E-7CD0-A049-9346-78CFAE901D40}"/>
          </ac:spMkLst>
        </pc:spChg>
        <pc:spChg chg="del">
          <ac:chgData name="Ann-Karin Hardie Olsen" userId="e320bee9-3c44-4263-bfad-c0288f2c0ec5" providerId="ADAL" clId="{68661585-E2D9-48A8-8EB6-694134DACEFC}" dt="2024-12-22T08:38:29.868" v="118" actId="478"/>
          <ac:spMkLst>
            <pc:docMk/>
            <pc:sldMk cId="3766932299" sldId="273"/>
            <ac:spMk id="5" creationId="{2C84C151-CBD3-5CF4-021B-B2C0E7F40DAA}"/>
          </ac:spMkLst>
        </pc:spChg>
      </pc:sldChg>
      <pc:sldChg chg="addSp delSp modSp mod">
        <pc:chgData name="Ann-Karin Hardie Olsen" userId="e320bee9-3c44-4263-bfad-c0288f2c0ec5" providerId="ADAL" clId="{68661585-E2D9-48A8-8EB6-694134DACEFC}" dt="2024-12-22T08:38:58.316" v="126" actId="20577"/>
        <pc:sldMkLst>
          <pc:docMk/>
          <pc:sldMk cId="3240163265" sldId="274"/>
        </pc:sldMkLst>
        <pc:spChg chg="add mod">
          <ac:chgData name="Ann-Karin Hardie Olsen" userId="e320bee9-3c44-4263-bfad-c0288f2c0ec5" providerId="ADAL" clId="{68661585-E2D9-48A8-8EB6-694134DACEFC}" dt="2024-12-22T08:38:45.542" v="120"/>
          <ac:spMkLst>
            <pc:docMk/>
            <pc:sldMk cId="3240163265" sldId="274"/>
            <ac:spMk id="2" creationId="{BC677DAA-F4D5-8809-5141-6A861D51F6F7}"/>
          </ac:spMkLst>
        </pc:spChg>
        <pc:spChg chg="add mod">
          <ac:chgData name="Ann-Karin Hardie Olsen" userId="e320bee9-3c44-4263-bfad-c0288f2c0ec5" providerId="ADAL" clId="{68661585-E2D9-48A8-8EB6-694134DACEFC}" dt="2024-12-22T08:38:58.316" v="126" actId="20577"/>
          <ac:spMkLst>
            <pc:docMk/>
            <pc:sldMk cId="3240163265" sldId="274"/>
            <ac:spMk id="4" creationId="{E85C077B-B44B-1E03-856C-C6AA6BEE9AB7}"/>
          </ac:spMkLst>
        </pc:spChg>
        <pc:spChg chg="del">
          <ac:chgData name="Ann-Karin Hardie Olsen" userId="e320bee9-3c44-4263-bfad-c0288f2c0ec5" providerId="ADAL" clId="{68661585-E2D9-48A8-8EB6-694134DACEFC}" dt="2024-12-22T08:38:50.662" v="121" actId="478"/>
          <ac:spMkLst>
            <pc:docMk/>
            <pc:sldMk cId="3240163265" sldId="274"/>
            <ac:spMk id="5" creationId="{2C84C151-CBD3-5CF4-021B-B2C0E7F40DAA}"/>
          </ac:spMkLst>
        </pc:spChg>
      </pc:sldChg>
    </pc:docChg>
  </pc:docChgLst>
  <pc:docChgLst>
    <pc:chgData name="Ann-Karin Hardie Olsen" userId="S::anka@nilu.no::e320bee9-3c44-4263-bfad-c0288f2c0ec5" providerId="AD" clId="Web-{FE269BE8-7877-324B-309C-31D343D9157F}"/>
    <pc:docChg chg="modSld">
      <pc:chgData name="Ann-Karin Hardie Olsen" userId="S::anka@nilu.no::e320bee9-3c44-4263-bfad-c0288f2c0ec5" providerId="AD" clId="Web-{FE269BE8-7877-324B-309C-31D343D9157F}" dt="2024-11-01T15:09:58.638" v="36"/>
      <pc:docMkLst>
        <pc:docMk/>
      </pc:docMkLst>
      <pc:sldChg chg="addSp delSp modSp">
        <pc:chgData name="Ann-Karin Hardie Olsen" userId="S::anka@nilu.no::e320bee9-3c44-4263-bfad-c0288f2c0ec5" providerId="AD" clId="Web-{FE269BE8-7877-324B-309C-31D343D9157F}" dt="2024-11-01T15:09:58.638" v="36"/>
        <pc:sldMkLst>
          <pc:docMk/>
          <pc:sldMk cId="3796257797" sldId="262"/>
        </pc:sldMkLst>
        <pc:spChg chg="mod">
          <ac:chgData name="Ann-Karin Hardie Olsen" userId="S::anka@nilu.no::e320bee9-3c44-4263-bfad-c0288f2c0ec5" providerId="AD" clId="Web-{FE269BE8-7877-324B-309C-31D343D9157F}" dt="2024-11-01T15:09:54.091" v="35" actId="20577"/>
          <ac:spMkLst>
            <pc:docMk/>
            <pc:sldMk cId="3796257797" sldId="262"/>
            <ac:spMk id="2" creationId="{E1C6E756-B19F-40C5-2E2C-15C32AF2D2AF}"/>
          </ac:spMkLst>
        </pc:spChg>
        <pc:spChg chg="del">
          <ac:chgData name="Ann-Karin Hardie Olsen" userId="S::anka@nilu.no::e320bee9-3c44-4263-bfad-c0288f2c0ec5" providerId="AD" clId="Web-{FE269BE8-7877-324B-309C-31D343D9157F}" dt="2024-11-01T15:09:58.638" v="36"/>
          <ac:spMkLst>
            <pc:docMk/>
            <pc:sldMk cId="3796257797" sldId="262"/>
            <ac:spMk id="3" creationId="{85C30EE4-AF3D-26C6-8477-75006A80F132}"/>
          </ac:spMkLst>
        </pc:spChg>
        <pc:spChg chg="add mod">
          <ac:chgData name="Ann-Karin Hardie Olsen" userId="S::anka@nilu.no::e320bee9-3c44-4263-bfad-c0288f2c0ec5" providerId="AD" clId="Web-{FE269BE8-7877-324B-309C-31D343D9157F}" dt="2024-11-01T15:09:58.638" v="36"/>
          <ac:spMkLst>
            <pc:docMk/>
            <pc:sldMk cId="3796257797" sldId="262"/>
            <ac:spMk id="5" creationId="{1F7B9093-B544-8B38-D5E5-677EFF47460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8091F5-C81D-C585-65B1-A06347102CF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9EF7B0-66EE-80EB-3648-ADABD18AF3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2228C1-398E-1AD2-80C5-F65CED73B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349FFC-B9CB-BBED-57B9-7969CF47F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80E68-56ED-9FAE-27A4-E07FEEFAD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6041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4D17B5-64CD-F9BC-DFC7-36B2A6B8FC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39B326-1346-CEFF-0C48-524684921C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467F5-F9CF-0650-26F1-A3F3E6151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FA1BE0-BD8F-528B-ACF5-09684E6475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1B8751-4AB0-61A3-7548-5EF858B44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3565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221717-BB24-64A4-BF80-92E49849C5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D48F64-FD5C-F2AA-D9DF-9F3E20CC49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2F60BE-7121-E283-E80C-C697DF462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37E766-1B3C-FECD-FB8C-128E428C5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DF8B3-E613-274A-E615-A63591FF82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5749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DD047D-0DA7-2358-1957-808B8BAF1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BBCC27-8FC8-3618-3D4B-5FB1BD12F3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C3425A-C4DF-82CD-0FFD-CD912F6F5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22696B-5C71-8DDC-5EDB-9B23F3853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B87DA0-234B-D0C5-81BB-56408C9D0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898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78B311-F21E-6456-6539-C2036D4BAF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6F9235-D75F-671B-36D9-84D71F59A8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AEACB2-68EB-4191-5B8F-62DF433D4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A482C7-65A5-135C-107C-740766DD7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50197-DC3F-64CC-D873-DAF93B6FF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128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56A8E-38F2-F816-E85D-C55E0BF46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E12792-1D80-DE63-0744-6BC9B3EF2F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A415AB-AB7E-FF9F-6C9A-A8F2D6E06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E5E991-2AD3-B637-ECA0-039163099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24B97F-A624-397E-58A0-1ABE90437B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650B6E-EA9B-71FF-8EE5-6FAC48A79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592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ADC9E-01F0-0F9B-B366-2F5FEA549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0F2F7B-F8A7-A214-BAD8-EFE520BB49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7976B3-84E5-8D1E-1537-CD6CC53D9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2FC9F05-31FC-62F9-D5A5-48F07D1920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8420AB-E9D2-F139-2D0E-6AC21C4502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1C594C4-49DB-DE7E-D6F0-1092AC9FC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9210BF-8C54-64C3-9FBD-B79AD1452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E4B13D-DE6B-9BAC-C8F8-6A8398D2A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136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E326D-615F-B095-7D27-52EC03050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0BB778-14DC-C59B-E03E-4F79908B9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A3E106-9EDA-9782-682F-EEB3D7F61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5FAEDE-63D6-0BB9-3B5E-D958107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884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4B5C6C-22C5-17BC-D153-A1B27AC17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A70FE5-A5B4-962A-0E19-E809AF78D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06E63B6-75EE-B153-2A58-ABFA19DD4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6466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6E29DD-97FF-0699-C9B0-ADAC4F47E7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8FA9E-BC37-8BFE-666D-A2CA3F9B62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CBDE41-A352-D79C-3667-5A909F2A5C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F1F22E-7382-C8E5-FF43-6B2383ECB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F64906-4374-33A4-E902-8060462CBB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DBF41A-4113-AEAB-57EF-FBB627193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0157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456B6-8D08-6764-B45A-90FA475AE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011497-C44C-C0CC-3FA6-38316F3EF9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93E4CC-B151-D3F1-9822-2B6ACA0F91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BD9037-4F77-A628-F7BD-48D6A3A1E9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E68C11-4888-B72A-FFCD-32E271A4C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430583-5786-7D3D-973D-D600965CA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5998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880D9A-D088-4071-7386-9AEE4A7FFD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7F3B87-B0C4-1015-02F0-ED21449DAF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C2548-54E6-DE87-6245-10236911FA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369FAB-97F1-43A7-B615-C333CC773402}" type="datetimeFigureOut">
              <a:rPr lang="en-GB" smtClean="0"/>
              <a:t>22/12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602FF7-09DB-7198-2847-A9E9ECCAA1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C0435-7778-0DCC-5419-F5A1B05336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E7FAA2-B532-44F1-88D7-8A67052D4C5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805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E1C6E756-B19F-40C5-2E2C-15C32AF2D2A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nb-NO" dirty="0"/>
              <a:t>Training to </a:t>
            </a:r>
            <a:r>
              <a:rPr lang="nb-NO" dirty="0" err="1"/>
              <a:t>select</a:t>
            </a:r>
            <a:r>
              <a:rPr lang="nb-NO" dirty="0"/>
              <a:t> </a:t>
            </a:r>
            <a:r>
              <a:rPr lang="nb-NO" dirty="0" err="1"/>
              <a:t>which</a:t>
            </a:r>
            <a:r>
              <a:rPr lang="nb-NO" dirty="0"/>
              <a:t> </a:t>
            </a:r>
            <a:r>
              <a:rPr lang="nb-NO" dirty="0" err="1"/>
              <a:t>testicular</a:t>
            </a:r>
            <a:r>
              <a:rPr lang="nb-NO" dirty="0"/>
              <a:t> </a:t>
            </a:r>
            <a:r>
              <a:rPr lang="nb-NO" dirty="0" err="1"/>
              <a:t>comets</a:t>
            </a:r>
            <a:r>
              <a:rPr lang="nb-NO" dirty="0"/>
              <a:t> to score</a:t>
            </a:r>
            <a:br>
              <a:rPr lang="nb-NO" dirty="0"/>
            </a:br>
            <a:r>
              <a:rPr lang="nb-NO" dirty="0"/>
              <a:t>-</a:t>
            </a:r>
            <a:r>
              <a:rPr lang="nb-NO" dirty="0" err="1"/>
              <a:t>without</a:t>
            </a:r>
            <a:r>
              <a:rPr lang="nb-NO" dirty="0"/>
              <a:t> </a:t>
            </a:r>
            <a:r>
              <a:rPr lang="nb-NO" dirty="0" err="1"/>
              <a:t>results</a:t>
            </a:r>
            <a:r>
              <a:rPr lang="nb-NO" dirty="0"/>
              <a:t> </a:t>
            </a:r>
          </a:p>
        </p:txBody>
      </p:sp>
      <p:sp>
        <p:nvSpPr>
          <p:cNvPr id="5" name="Subtitle 4">
            <a:extLst>
              <a:ext uri="{FF2B5EF4-FFF2-40B4-BE49-F238E27FC236}">
                <a16:creationId xmlns:a16="http://schemas.microsoft.com/office/drawing/2014/main" id="{1F7B9093-B544-8B38-D5E5-677EFF47460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Use these images to train - then open the file with results to compare and learn  </a:t>
            </a:r>
          </a:p>
        </p:txBody>
      </p:sp>
    </p:spTree>
    <p:extLst>
      <p:ext uri="{BB962C8B-B14F-4D97-AF65-F5344CB8AC3E}">
        <p14:creationId xmlns:p14="http://schemas.microsoft.com/office/powerpoint/2010/main" val="37962577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untreated)</a:t>
            </a:r>
            <a:endParaRPr lang="en-GB" sz="4000" dirty="0"/>
          </a:p>
        </p:txBody>
      </p:sp>
      <p:pic>
        <p:nvPicPr>
          <p:cNvPr id="3" name="Picture 2" descr="A group of white dots in the sky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8E7EFB5E-5E4C-FEC8-9B6D-606ACAB1FF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6213" y="895318"/>
            <a:ext cx="772770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05663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untreated)</a:t>
            </a:r>
            <a:endParaRPr lang="en-GB" sz="4000" dirty="0"/>
          </a:p>
        </p:txBody>
      </p:sp>
      <p:pic>
        <p:nvPicPr>
          <p:cNvPr id="3" name="Picture 2" descr="A group of white dots in the sky&#10;&#10;Description automatically generated">
            <a:extLst>
              <a:ext uri="{FF2B5EF4-FFF2-40B4-BE49-F238E27FC236}">
                <a16:creationId xmlns:a16="http://schemas.microsoft.com/office/drawing/2014/main" id="{21EF11A6-3A81-3CF3-26B8-1E24486C2D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6608" y="885664"/>
            <a:ext cx="7724581" cy="5758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626503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A368E0E4-8F96-128E-F319-1115069B32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0489" y="884092"/>
            <a:ext cx="7727700" cy="5760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BBFB433D-1440-CBA7-057B-F181314747F8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</a:t>
            </a:r>
            <a:r>
              <a:rPr lang="nb-NO" sz="4000" dirty="0" err="1"/>
              <a:t>treated</a:t>
            </a:r>
            <a:r>
              <a:rPr lang="nb-NO" sz="4000" dirty="0"/>
              <a:t>), </a:t>
            </a:r>
            <a:r>
              <a:rPr lang="en-US" sz="4000" dirty="0"/>
              <a:t>low damage (~20 % TI)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112814141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white lights in a black background&#10;&#10;Description automatically generated">
            <a:extLst>
              <a:ext uri="{FF2B5EF4-FFF2-40B4-BE49-F238E27FC236}">
                <a16:creationId xmlns:a16="http://schemas.microsoft.com/office/drawing/2014/main" id="{20EE38DA-2031-D6CD-C9F3-458CC6E2A2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457" y="932350"/>
            <a:ext cx="7727700" cy="5760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36B104F8-2D7A-E331-814D-63F2429F34CC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</a:t>
            </a:r>
            <a:r>
              <a:rPr lang="nb-NO" sz="4000" dirty="0" err="1"/>
              <a:t>treated</a:t>
            </a:r>
            <a:r>
              <a:rPr lang="nb-NO" sz="4000" dirty="0"/>
              <a:t>), </a:t>
            </a:r>
            <a:r>
              <a:rPr lang="en-US" sz="4000" dirty="0"/>
              <a:t>low damage (~20 % TI)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8522680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white ovals in a black background&#10;&#10;Description automatically generated">
            <a:extLst>
              <a:ext uri="{FF2B5EF4-FFF2-40B4-BE49-F238E27FC236}">
                <a16:creationId xmlns:a16="http://schemas.microsoft.com/office/drawing/2014/main" id="{77A90F17-2A71-90B5-D5C3-78BC88136E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978" y="881984"/>
            <a:ext cx="7727700" cy="5760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48913E0E-7CD0-A049-9346-78CFAE901D40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</a:t>
            </a:r>
            <a:r>
              <a:rPr lang="nb-NO" sz="4000" dirty="0" err="1"/>
              <a:t>treated</a:t>
            </a:r>
            <a:r>
              <a:rPr lang="nb-NO" sz="4000" dirty="0"/>
              <a:t>)</a:t>
            </a:r>
            <a:r>
              <a:rPr lang="en-US" sz="4000" dirty="0"/>
              <a:t>, high damage (~60 % TI)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37669322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white ovals in the dark&#10;&#10;Description automatically generated">
            <a:extLst>
              <a:ext uri="{FF2B5EF4-FFF2-40B4-BE49-F238E27FC236}">
                <a16:creationId xmlns:a16="http://schemas.microsoft.com/office/drawing/2014/main" id="{A4F48F27-B059-9BA4-AF2C-6C15965A3B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4233" y="909204"/>
            <a:ext cx="7727703" cy="5760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E85C077B-B44B-1E03-856C-C6AA6BEE9AB7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PS (</a:t>
            </a:r>
            <a:r>
              <a:rPr lang="nb-NO" sz="4000" dirty="0" err="1"/>
              <a:t>treated</a:t>
            </a:r>
            <a:r>
              <a:rPr lang="nb-NO" sz="4000" dirty="0"/>
              <a:t>)</a:t>
            </a:r>
            <a:r>
              <a:rPr lang="en-US" sz="4000" dirty="0"/>
              <a:t>, high damage (~60 % TI)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3240163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8">
            <a:extLst>
              <a:ext uri="{FF2B5EF4-FFF2-40B4-BE49-F238E27FC236}">
                <a16:creationId xmlns:a16="http://schemas.microsoft.com/office/drawing/2014/main" id="{1E473976-37DD-73A6-C305-A08443EFA22A}"/>
              </a:ext>
            </a:extLst>
          </p:cNvPr>
          <p:cNvSpPr txBox="1"/>
          <p:nvPr/>
        </p:nvSpPr>
        <p:spPr>
          <a:xfrm>
            <a:off x="1881094" y="934889"/>
            <a:ext cx="306097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/>
              <a:t>Untreated</a:t>
            </a:r>
            <a:endParaRPr lang="en-US"/>
          </a:p>
        </p:txBody>
      </p:sp>
      <p:pic>
        <p:nvPicPr>
          <p:cNvPr id="8" name="Picture 7" descr="A group of white circles in the sky&#10;&#10;Description automatically generated">
            <a:extLst>
              <a:ext uri="{FF2B5EF4-FFF2-40B4-BE49-F238E27FC236}">
                <a16:creationId xmlns:a16="http://schemas.microsoft.com/office/drawing/2014/main" id="{F7CAA5AC-6E3D-603B-B040-64AF40C720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003" y="1273628"/>
            <a:ext cx="3370312" cy="2512131"/>
          </a:xfrm>
          <a:prstGeom prst="rect">
            <a:avLst/>
          </a:prstGeom>
        </p:spPr>
      </p:pic>
      <p:pic>
        <p:nvPicPr>
          <p:cNvPr id="10" name="Picture 9" descr="A group of white circles in a black background&#10;&#10;Description automatically generated">
            <a:extLst>
              <a:ext uri="{FF2B5EF4-FFF2-40B4-BE49-F238E27FC236}">
                <a16:creationId xmlns:a16="http://schemas.microsoft.com/office/drawing/2014/main" id="{51DE74BC-9860-65F8-A614-98FC3AD553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6003" y="3934715"/>
            <a:ext cx="3370312" cy="2512131"/>
          </a:xfrm>
          <a:prstGeom prst="rect">
            <a:avLst/>
          </a:prstGeom>
        </p:spPr>
      </p:pic>
      <p:pic>
        <p:nvPicPr>
          <p:cNvPr id="20" name="Picture 19" descr="A group of white dots on a black background&#10;&#10;Description automatically generated">
            <a:extLst>
              <a:ext uri="{FF2B5EF4-FFF2-40B4-BE49-F238E27FC236}">
                <a16:creationId xmlns:a16="http://schemas.microsoft.com/office/drawing/2014/main" id="{6A0B188C-6D8B-2103-2FE7-0940470DED7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84" y="1273628"/>
            <a:ext cx="3370312" cy="2512131"/>
          </a:xfrm>
          <a:prstGeom prst="rect">
            <a:avLst/>
          </a:prstGeom>
        </p:spPr>
      </p:pic>
      <p:pic>
        <p:nvPicPr>
          <p:cNvPr id="30" name="Picture 29" descr="A group of ovals in a black background&#10;&#10;Description automatically generated">
            <a:extLst>
              <a:ext uri="{FF2B5EF4-FFF2-40B4-BE49-F238E27FC236}">
                <a16:creationId xmlns:a16="http://schemas.microsoft.com/office/drawing/2014/main" id="{BA106BDF-6FFD-6422-4192-582C03B7A1C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0284" y="3940223"/>
            <a:ext cx="3370312" cy="2512131"/>
          </a:xfrm>
          <a:prstGeom prst="rect">
            <a:avLst/>
          </a:prstGeom>
        </p:spPr>
      </p:pic>
      <p:pic>
        <p:nvPicPr>
          <p:cNvPr id="32" name="Picture 31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A9F0FB47-4825-83D1-51C0-BEBF22F1D9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5557" y="1272907"/>
            <a:ext cx="3370314" cy="2512132"/>
          </a:xfrm>
          <a:prstGeom prst="rect">
            <a:avLst/>
          </a:prstGeom>
        </p:spPr>
      </p:pic>
      <p:pic>
        <p:nvPicPr>
          <p:cNvPr id="36" name="Picture 35" descr="A group of white lights in the sky&#10;&#10;Description automatically generated">
            <a:extLst>
              <a:ext uri="{FF2B5EF4-FFF2-40B4-BE49-F238E27FC236}">
                <a16:creationId xmlns:a16="http://schemas.microsoft.com/office/drawing/2014/main" id="{CBBD497F-DA4D-539D-AED6-4FE3A1DC2CC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5558" y="3934715"/>
            <a:ext cx="3370312" cy="2512131"/>
          </a:xfrm>
          <a:prstGeom prst="rect">
            <a:avLst/>
          </a:prstGeom>
        </p:spPr>
      </p:pic>
      <p:sp>
        <p:nvSpPr>
          <p:cNvPr id="3" name="TextBox 3">
            <a:extLst>
              <a:ext uri="{FF2B5EF4-FFF2-40B4-BE49-F238E27FC236}">
                <a16:creationId xmlns:a16="http://schemas.microsoft.com/office/drawing/2014/main" id="{2FD95B36-C7F0-0738-62DB-D2070F909049}"/>
              </a:ext>
            </a:extLst>
          </p:cNvPr>
          <p:cNvSpPr txBox="1"/>
          <p:nvPr/>
        </p:nvSpPr>
        <p:spPr>
          <a:xfrm>
            <a:off x="4435557" y="938956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low damage ( ~20 % TI)</a:t>
            </a:r>
            <a:endParaRPr lang="en-US" dirty="0"/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DCE8D09F-A6D8-570F-2FEE-BEA0E1E2217C}"/>
              </a:ext>
            </a:extLst>
          </p:cNvPr>
          <p:cNvSpPr txBox="1"/>
          <p:nvPr/>
        </p:nvSpPr>
        <p:spPr>
          <a:xfrm>
            <a:off x="7933261" y="934498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high damage ( ~60 % TI)</a:t>
            </a:r>
            <a:endParaRPr lang="en-US" dirty="0"/>
          </a:p>
        </p:txBody>
      </p:sp>
      <p:sp>
        <p:nvSpPr>
          <p:cNvPr id="9" name="Rektangel 8">
            <a:extLst>
              <a:ext uri="{FF2B5EF4-FFF2-40B4-BE49-F238E27FC236}">
                <a16:creationId xmlns:a16="http://schemas.microsoft.com/office/drawing/2014/main" id="{AD908C7F-5252-71CA-38B3-E844BDA1A9DF}"/>
              </a:ext>
            </a:extLst>
          </p:cNvPr>
          <p:cNvSpPr/>
          <p:nvPr/>
        </p:nvSpPr>
        <p:spPr>
          <a:xfrm>
            <a:off x="804124" y="941636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140A44A4-CD15-251B-B597-90EB43AFE164}"/>
              </a:ext>
            </a:extLst>
          </p:cNvPr>
          <p:cNvSpPr/>
          <p:nvPr/>
        </p:nvSpPr>
        <p:spPr>
          <a:xfrm>
            <a:off x="4399192" y="937671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DF1E7B3A-85D2-E99F-6BF0-DD14A04D4CE4}"/>
              </a:ext>
            </a:extLst>
          </p:cNvPr>
          <p:cNvSpPr/>
          <p:nvPr/>
        </p:nvSpPr>
        <p:spPr>
          <a:xfrm>
            <a:off x="7958405" y="934498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8ADE8CE0-A8C5-0353-3B83-07DA6C16F597}"/>
              </a:ext>
            </a:extLst>
          </p:cNvPr>
          <p:cNvSpPr>
            <a:spLocks noGrp="1"/>
          </p:cNvSpPr>
          <p:nvPr/>
        </p:nvSpPr>
        <p:spPr>
          <a:xfrm>
            <a:off x="746608" y="-106268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All round nucleoids (</a:t>
            </a:r>
            <a:r>
              <a:rPr lang="nb-NO" sz="4000" dirty="0" err="1"/>
              <a:t>untreated</a:t>
            </a:r>
            <a:r>
              <a:rPr lang="nb-NO" sz="4000" dirty="0"/>
              <a:t>, </a:t>
            </a:r>
            <a:r>
              <a:rPr lang="nb-NO" sz="4000" dirty="0" err="1"/>
              <a:t>treated</a:t>
            </a:r>
            <a:r>
              <a:rPr lang="nb-NO" sz="4000" dirty="0"/>
              <a:t>)</a:t>
            </a:r>
          </a:p>
          <a:p>
            <a:r>
              <a:rPr lang="nb-NO" sz="2800" dirty="0" err="1"/>
              <a:t>Overview</a:t>
            </a:r>
            <a:r>
              <a:rPr lang="nb-NO" sz="2800" dirty="0"/>
              <a:t>, </a:t>
            </a:r>
            <a:r>
              <a:rPr lang="nb-NO" sz="2800" dirty="0" err="1"/>
              <a:t>each</a:t>
            </a:r>
            <a:r>
              <a:rPr lang="nb-NO" sz="2800" dirty="0"/>
              <a:t> image is </a:t>
            </a:r>
            <a:r>
              <a:rPr lang="nb-NO" sz="2800" dirty="0" err="1"/>
              <a:t>displayed</a:t>
            </a:r>
            <a:r>
              <a:rPr lang="nb-NO" sz="2800" dirty="0"/>
              <a:t> in separate slides </a:t>
            </a:r>
            <a:r>
              <a:rPr lang="nb-NO" sz="2800" dirty="0" err="1"/>
              <a:t>below</a:t>
            </a:r>
            <a:endParaRPr lang="en-GB" sz="2800" dirty="0"/>
          </a:p>
        </p:txBody>
      </p:sp>
    </p:spTree>
    <p:extLst>
      <p:ext uri="{BB962C8B-B14F-4D97-AF65-F5344CB8AC3E}">
        <p14:creationId xmlns:p14="http://schemas.microsoft.com/office/powerpoint/2010/main" val="4225952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All round nucleoids (untreated)</a:t>
            </a:r>
            <a:endParaRPr lang="en-GB" sz="4000" dirty="0"/>
          </a:p>
        </p:txBody>
      </p:sp>
      <p:pic>
        <p:nvPicPr>
          <p:cNvPr id="6" name="Picture 5" descr="A group of white circles in the sky&#10;&#10;Description automatically generated">
            <a:extLst>
              <a:ext uri="{FF2B5EF4-FFF2-40B4-BE49-F238E27FC236}">
                <a16:creationId xmlns:a16="http://schemas.microsoft.com/office/drawing/2014/main" id="{64FECE28-EBAE-4483-5E93-903ED8AFCB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0942" y="1032843"/>
            <a:ext cx="772770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472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2C84C151-CBD3-5CF4-021B-B2C0E7F40DAA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/>
              <a:t>All round nucleoids (untreated)</a:t>
            </a:r>
            <a:endParaRPr lang="en-GB" sz="4000" dirty="0"/>
          </a:p>
        </p:txBody>
      </p:sp>
      <p:pic>
        <p:nvPicPr>
          <p:cNvPr id="2" name="Picture 1" descr="A group of white circles in a black background&#10;&#10;Description automatically generated">
            <a:extLst>
              <a:ext uri="{FF2B5EF4-FFF2-40B4-BE49-F238E27FC236}">
                <a16:creationId xmlns:a16="http://schemas.microsoft.com/office/drawing/2014/main" id="{FD894C57-F724-2E1A-B5D3-9532765DC5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6089" y="952028"/>
            <a:ext cx="772770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7946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4B6AEE55-85B2-9BE1-2B17-E6A430E6E9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5499" y="944159"/>
            <a:ext cx="7727702" cy="5760000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64F3FD4B-F5A0-25D1-299F-A5E33BA882F1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 dirty="0"/>
              <a:t>All round nucleoids (</a:t>
            </a:r>
            <a:r>
              <a:rPr lang="nb-NO" sz="3600" dirty="0" err="1"/>
              <a:t>treated</a:t>
            </a:r>
            <a:r>
              <a:rPr lang="nb-NO" sz="3600" dirty="0"/>
              <a:t>)</a:t>
            </a:r>
            <a:r>
              <a:rPr lang="en-US" sz="3600" dirty="0"/>
              <a:t>, low damage (~20 % TI)</a:t>
            </a:r>
            <a:endParaRPr lang="en-GB" sz="3600" dirty="0"/>
          </a:p>
        </p:txBody>
      </p:sp>
    </p:spTree>
    <p:extLst>
      <p:ext uri="{BB962C8B-B14F-4D97-AF65-F5344CB8AC3E}">
        <p14:creationId xmlns:p14="http://schemas.microsoft.com/office/powerpoint/2010/main" val="29620404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oup of white lights in the sky&#10;&#10;Description automatically generated">
            <a:extLst>
              <a:ext uri="{FF2B5EF4-FFF2-40B4-BE49-F238E27FC236}">
                <a16:creationId xmlns:a16="http://schemas.microsoft.com/office/drawing/2014/main" id="{B9AA0672-07E9-7BA5-8320-9C3D9634DC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043" y="952029"/>
            <a:ext cx="7727701" cy="5760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A8A0D459-DB67-2519-DF44-AA906A7A07F7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 dirty="0"/>
              <a:t>All round nucleoids (</a:t>
            </a:r>
            <a:r>
              <a:rPr lang="nb-NO" sz="3600" dirty="0" err="1"/>
              <a:t>treated</a:t>
            </a:r>
            <a:r>
              <a:rPr lang="nb-NO" sz="3600" dirty="0"/>
              <a:t>)</a:t>
            </a:r>
            <a:r>
              <a:rPr lang="en-US" sz="3600" dirty="0"/>
              <a:t>, low damage (~20 % TI)</a:t>
            </a:r>
            <a:endParaRPr lang="en-GB" sz="3600" dirty="0"/>
          </a:p>
        </p:txBody>
      </p:sp>
    </p:spTree>
    <p:extLst>
      <p:ext uri="{BB962C8B-B14F-4D97-AF65-F5344CB8AC3E}">
        <p14:creationId xmlns:p14="http://schemas.microsoft.com/office/powerpoint/2010/main" val="11867889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white dots on a black background&#10;&#10;Description automatically generated">
            <a:extLst>
              <a:ext uri="{FF2B5EF4-FFF2-40B4-BE49-F238E27FC236}">
                <a16:creationId xmlns:a16="http://schemas.microsoft.com/office/drawing/2014/main" id="{B471BEA3-40A4-D260-3169-EBA7DF82A0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364" y="885262"/>
            <a:ext cx="7727701" cy="5760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89F865EF-E7F0-D126-9E97-27D2B08CD23F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 dirty="0"/>
              <a:t>All round nucleoids (</a:t>
            </a:r>
            <a:r>
              <a:rPr lang="nb-NO" sz="3600" dirty="0" err="1"/>
              <a:t>treated</a:t>
            </a:r>
            <a:r>
              <a:rPr lang="nb-NO" sz="3600" dirty="0"/>
              <a:t>)</a:t>
            </a:r>
            <a:r>
              <a:rPr lang="en-US" sz="3600" dirty="0"/>
              <a:t>, low damage (~60 % TI)</a:t>
            </a:r>
            <a:endParaRPr lang="en-GB" sz="3600" dirty="0"/>
          </a:p>
        </p:txBody>
      </p:sp>
    </p:spTree>
    <p:extLst>
      <p:ext uri="{BB962C8B-B14F-4D97-AF65-F5344CB8AC3E}">
        <p14:creationId xmlns:p14="http://schemas.microsoft.com/office/powerpoint/2010/main" val="19417409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oup of ovals in a black background&#10;&#10;Description automatically generated">
            <a:extLst>
              <a:ext uri="{FF2B5EF4-FFF2-40B4-BE49-F238E27FC236}">
                <a16:creationId xmlns:a16="http://schemas.microsoft.com/office/drawing/2014/main" id="{119A14BE-7F68-17CC-A711-4B8FE157B2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149" y="960456"/>
            <a:ext cx="7727701" cy="5760000"/>
          </a:xfrm>
          <a:prstGeom prst="rect">
            <a:avLst/>
          </a:prstGeom>
        </p:spPr>
      </p:pic>
      <p:sp>
        <p:nvSpPr>
          <p:cNvPr id="4" name="Title 1">
            <a:extLst>
              <a:ext uri="{FF2B5EF4-FFF2-40B4-BE49-F238E27FC236}">
                <a16:creationId xmlns:a16="http://schemas.microsoft.com/office/drawing/2014/main" id="{F8EA0D04-579E-0BCF-7329-5F5BBAF24149}"/>
              </a:ext>
            </a:extLst>
          </p:cNvPr>
          <p:cNvSpPr>
            <a:spLocks noGrp="1"/>
          </p:cNvSpPr>
          <p:nvPr/>
        </p:nvSpPr>
        <p:spPr>
          <a:xfrm>
            <a:off x="239485" y="-33957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3600" dirty="0"/>
              <a:t>All round nucleoids (</a:t>
            </a:r>
            <a:r>
              <a:rPr lang="nb-NO" sz="3600" dirty="0" err="1"/>
              <a:t>treated</a:t>
            </a:r>
            <a:r>
              <a:rPr lang="nb-NO" sz="3600" dirty="0"/>
              <a:t>)</a:t>
            </a:r>
            <a:r>
              <a:rPr lang="en-US" sz="3600" dirty="0"/>
              <a:t>, low damage (~60 % TI)</a:t>
            </a:r>
            <a:endParaRPr lang="en-GB" sz="3600" dirty="0"/>
          </a:p>
        </p:txBody>
      </p:sp>
    </p:spTree>
    <p:extLst>
      <p:ext uri="{BB962C8B-B14F-4D97-AF65-F5344CB8AC3E}">
        <p14:creationId xmlns:p14="http://schemas.microsoft.com/office/powerpoint/2010/main" val="27353781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group of white dots in the sky with Gallery Arcturus in the background&#10;&#10;Description automatically generated">
            <a:extLst>
              <a:ext uri="{FF2B5EF4-FFF2-40B4-BE49-F238E27FC236}">
                <a16:creationId xmlns:a16="http://schemas.microsoft.com/office/drawing/2014/main" id="{E188B93C-8639-C203-22E8-813D7E69E2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573" y="1303499"/>
            <a:ext cx="3371209" cy="2512800"/>
          </a:xfrm>
          <a:prstGeom prst="rect">
            <a:avLst/>
          </a:prstGeom>
        </p:spPr>
      </p:pic>
      <p:pic>
        <p:nvPicPr>
          <p:cNvPr id="39" name="Picture 38" descr="A group of bright lights in the sky&#10;&#10;Description automatically generated">
            <a:extLst>
              <a:ext uri="{FF2B5EF4-FFF2-40B4-BE49-F238E27FC236}">
                <a16:creationId xmlns:a16="http://schemas.microsoft.com/office/drawing/2014/main" id="{8AE92749-A7B0-923A-9A1F-F602FFB729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0394" y="1312355"/>
            <a:ext cx="3371212" cy="2512802"/>
          </a:xfrm>
          <a:prstGeom prst="rect">
            <a:avLst/>
          </a:prstGeom>
        </p:spPr>
      </p:pic>
      <p:pic>
        <p:nvPicPr>
          <p:cNvPr id="45" name="Picture 44" descr="A group of white ovals in the dark&#10;&#10;Description automatically generated">
            <a:extLst>
              <a:ext uri="{FF2B5EF4-FFF2-40B4-BE49-F238E27FC236}">
                <a16:creationId xmlns:a16="http://schemas.microsoft.com/office/drawing/2014/main" id="{550BA22F-EB1B-179D-B689-96A1BED9A6B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217" y="4150115"/>
            <a:ext cx="3371209" cy="2512799"/>
          </a:xfrm>
          <a:prstGeom prst="rect">
            <a:avLst/>
          </a:prstGeom>
        </p:spPr>
      </p:pic>
      <p:pic>
        <p:nvPicPr>
          <p:cNvPr id="63" name="Picture 62" descr="A group of white lights in a black background&#10;&#10;Description automatically generated">
            <a:extLst>
              <a:ext uri="{FF2B5EF4-FFF2-40B4-BE49-F238E27FC236}">
                <a16:creationId xmlns:a16="http://schemas.microsoft.com/office/drawing/2014/main" id="{26C553A4-39C3-B683-43A8-AAFAFA7534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0394" y="4150112"/>
            <a:ext cx="3371212" cy="2512802"/>
          </a:xfrm>
          <a:prstGeom prst="rect">
            <a:avLst/>
          </a:prstGeom>
        </p:spPr>
      </p:pic>
      <p:pic>
        <p:nvPicPr>
          <p:cNvPr id="65" name="Picture 64" descr="A group of white ovals in a black background&#10;&#10;Description automatically generated">
            <a:extLst>
              <a:ext uri="{FF2B5EF4-FFF2-40B4-BE49-F238E27FC236}">
                <a16:creationId xmlns:a16="http://schemas.microsoft.com/office/drawing/2014/main" id="{7BD70376-81BE-9EE6-EFBE-681C78819EB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217" y="1344189"/>
            <a:ext cx="3371209" cy="2512800"/>
          </a:xfrm>
          <a:prstGeom prst="rect">
            <a:avLst/>
          </a:prstGeom>
        </p:spPr>
      </p:pic>
      <p:pic>
        <p:nvPicPr>
          <p:cNvPr id="2" name="Picture 1" descr="A group of white dots in the sky&#10;&#10;Description automatically generated">
            <a:extLst>
              <a:ext uri="{FF2B5EF4-FFF2-40B4-BE49-F238E27FC236}">
                <a16:creationId xmlns:a16="http://schemas.microsoft.com/office/drawing/2014/main" id="{BC7EB472-93A0-E6AD-FDBA-05BD2FFE489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4164" y="4153223"/>
            <a:ext cx="3371210" cy="2512380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id="{BD82E16F-2124-5C38-338A-1B2F9387DFFD}"/>
              </a:ext>
            </a:extLst>
          </p:cNvPr>
          <p:cNvSpPr>
            <a:spLocks noGrp="1"/>
          </p:cNvSpPr>
          <p:nvPr/>
        </p:nvSpPr>
        <p:spPr>
          <a:xfrm>
            <a:off x="694756" y="-103726"/>
            <a:ext cx="10515600" cy="12070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b-NO" sz="4000" dirty="0" err="1"/>
              <a:t>Primary</a:t>
            </a:r>
            <a:r>
              <a:rPr lang="nb-NO" sz="4000" dirty="0"/>
              <a:t> </a:t>
            </a:r>
            <a:r>
              <a:rPr lang="nb-NO" sz="4000" dirty="0" err="1"/>
              <a:t>spermatocytes</a:t>
            </a:r>
            <a:r>
              <a:rPr lang="nb-NO" sz="4000" dirty="0"/>
              <a:t> (PS)(</a:t>
            </a:r>
            <a:r>
              <a:rPr lang="nb-NO" sz="4000" dirty="0" err="1"/>
              <a:t>untreated</a:t>
            </a:r>
            <a:r>
              <a:rPr lang="nb-NO" sz="4000" dirty="0"/>
              <a:t>, </a:t>
            </a:r>
            <a:r>
              <a:rPr lang="nb-NO" sz="4000" dirty="0" err="1"/>
              <a:t>treated</a:t>
            </a:r>
            <a:r>
              <a:rPr lang="nb-NO" sz="4000" dirty="0"/>
              <a:t>)  </a:t>
            </a:r>
          </a:p>
          <a:p>
            <a:r>
              <a:rPr lang="nb-NO" sz="2800" dirty="0" err="1"/>
              <a:t>Overview</a:t>
            </a:r>
            <a:r>
              <a:rPr lang="nb-NO" sz="2800" dirty="0"/>
              <a:t>, </a:t>
            </a:r>
            <a:r>
              <a:rPr lang="nb-NO" sz="2800" dirty="0" err="1"/>
              <a:t>each</a:t>
            </a:r>
            <a:r>
              <a:rPr lang="nb-NO" sz="2800" dirty="0"/>
              <a:t> image is </a:t>
            </a:r>
            <a:r>
              <a:rPr lang="nb-NO" sz="2800" dirty="0" err="1"/>
              <a:t>displayed</a:t>
            </a:r>
            <a:r>
              <a:rPr lang="nb-NO" sz="2800" dirty="0"/>
              <a:t> in separate slides </a:t>
            </a:r>
            <a:r>
              <a:rPr lang="nb-NO" sz="2800" dirty="0" err="1"/>
              <a:t>below</a:t>
            </a:r>
            <a:endParaRPr lang="en-GB" sz="2800" dirty="0"/>
          </a:p>
        </p:txBody>
      </p:sp>
      <p:sp>
        <p:nvSpPr>
          <p:cNvPr id="7" name="TextBox 28">
            <a:extLst>
              <a:ext uri="{FF2B5EF4-FFF2-40B4-BE49-F238E27FC236}">
                <a16:creationId xmlns:a16="http://schemas.microsoft.com/office/drawing/2014/main" id="{6FAC50CF-6B16-E4F0-29BE-67EFB0AE766A}"/>
              </a:ext>
            </a:extLst>
          </p:cNvPr>
          <p:cNvSpPr txBox="1"/>
          <p:nvPr/>
        </p:nvSpPr>
        <p:spPr>
          <a:xfrm>
            <a:off x="1881094" y="961265"/>
            <a:ext cx="306097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Untreated</a:t>
            </a:r>
            <a:endParaRPr lang="en-US" dirty="0"/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A9E0B875-8326-1E63-473F-2F0B22F32B84}"/>
              </a:ext>
            </a:extLst>
          </p:cNvPr>
          <p:cNvSpPr txBox="1"/>
          <p:nvPr/>
        </p:nvSpPr>
        <p:spPr>
          <a:xfrm>
            <a:off x="4435557" y="965332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low damage (~20 % TI)</a:t>
            </a:r>
            <a:endParaRPr lang="en-US" dirty="0"/>
          </a:p>
        </p:txBody>
      </p:sp>
      <p:sp>
        <p:nvSpPr>
          <p:cNvPr id="9" name="TextBox 3">
            <a:extLst>
              <a:ext uri="{FF2B5EF4-FFF2-40B4-BE49-F238E27FC236}">
                <a16:creationId xmlns:a16="http://schemas.microsoft.com/office/drawing/2014/main" id="{7F35C565-BAD5-A6EA-452A-A030D1060479}"/>
              </a:ext>
            </a:extLst>
          </p:cNvPr>
          <p:cNvSpPr txBox="1"/>
          <p:nvPr/>
        </p:nvSpPr>
        <p:spPr>
          <a:xfrm>
            <a:off x="7985113" y="969666"/>
            <a:ext cx="351213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dirty="0"/>
              <a:t>Treated, high damage ( ~60 % TI)</a:t>
            </a:r>
            <a:endParaRPr lang="en-US" dirty="0"/>
          </a:p>
        </p:txBody>
      </p:sp>
      <p:sp>
        <p:nvSpPr>
          <p:cNvPr id="10" name="Rektangel 9">
            <a:extLst>
              <a:ext uri="{FF2B5EF4-FFF2-40B4-BE49-F238E27FC236}">
                <a16:creationId xmlns:a16="http://schemas.microsoft.com/office/drawing/2014/main" id="{DB9A0512-1743-CA52-7219-7E11A13B0D01}"/>
              </a:ext>
            </a:extLst>
          </p:cNvPr>
          <p:cNvSpPr/>
          <p:nvPr/>
        </p:nvSpPr>
        <p:spPr>
          <a:xfrm>
            <a:off x="672818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1" name="Rektangel 10">
            <a:extLst>
              <a:ext uri="{FF2B5EF4-FFF2-40B4-BE49-F238E27FC236}">
                <a16:creationId xmlns:a16="http://schemas.microsoft.com/office/drawing/2014/main" id="{2DF859A3-9054-0FE4-6306-D0AADC77F03A}"/>
              </a:ext>
            </a:extLst>
          </p:cNvPr>
          <p:cNvSpPr/>
          <p:nvPr/>
        </p:nvSpPr>
        <p:spPr>
          <a:xfrm>
            <a:off x="4308738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12" name="Rektangel 11">
            <a:extLst>
              <a:ext uri="{FF2B5EF4-FFF2-40B4-BE49-F238E27FC236}">
                <a16:creationId xmlns:a16="http://schemas.microsoft.com/office/drawing/2014/main" id="{47B6743C-A4D4-1FED-6974-AF6E0D6CE350}"/>
              </a:ext>
            </a:extLst>
          </p:cNvPr>
          <p:cNvSpPr/>
          <p:nvPr/>
        </p:nvSpPr>
        <p:spPr>
          <a:xfrm>
            <a:off x="8010276" y="1018330"/>
            <a:ext cx="3534069" cy="567731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04879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</TotalTime>
  <Words>228</Words>
  <Application>Microsoft Office PowerPoint</Application>
  <PresentationFormat>Widescreen</PresentationFormat>
  <Paragraphs>24</Paragraphs>
  <Slides>15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5</vt:i4>
      </vt:variant>
    </vt:vector>
  </HeadingPairs>
  <TitlesOfParts>
    <vt:vector size="19" baseType="lpstr">
      <vt:lpstr>Aptos</vt:lpstr>
      <vt:lpstr>Aptos Display</vt:lpstr>
      <vt:lpstr>Arial</vt:lpstr>
      <vt:lpstr>Office Theme</vt:lpstr>
      <vt:lpstr>Training to select which testicular comets to score -without results 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gying Zheng</dc:creator>
  <cp:lastModifiedBy>Ann-Karin Hardie Olsen</cp:lastModifiedBy>
  <cp:revision>16</cp:revision>
  <dcterms:created xsi:type="dcterms:W3CDTF">2024-09-10T16:37:13Z</dcterms:created>
  <dcterms:modified xsi:type="dcterms:W3CDTF">2024-12-22T08:41:23Z</dcterms:modified>
</cp:coreProperties>
</file>